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2">
  <p:sldMasterIdLst>
    <p:sldMasterId id="2147483648" r:id="rId1"/>
  </p:sldMasterIdLst>
  <p:notesMasterIdLst>
    <p:notesMasterId r:id="rId3"/>
  </p:notesMasterIdLst>
  <p:sldIdLst>
    <p:sldId id="394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705" autoAdjust="0"/>
  </p:normalViewPr>
  <p:slideViewPr>
    <p:cSldViewPr>
      <p:cViewPr>
        <p:scale>
          <a:sx n="73" d="100"/>
          <a:sy n="73" d="100"/>
        </p:scale>
        <p:origin x="-2946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C06062-2AC1-4CD2-9D01-D4A72F0C6204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E25804-2A89-4C7D-AAC2-EACC3055339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8866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83888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64095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0803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0018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3105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55081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597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57828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1569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31106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36715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6654B-016E-4294-AA16-BB881D6DFC8C}" type="datetimeFigureOut">
              <a:rPr lang="en-AU" smtClean="0"/>
              <a:t>1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D1254-10AC-408A-B1B7-6445568E133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2606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997020"/>
              </p:ext>
            </p:extLst>
          </p:nvPr>
        </p:nvGraphicFramePr>
        <p:xfrm>
          <a:off x="2044127" y="2133598"/>
          <a:ext cx="2769745" cy="5772606"/>
        </p:xfrm>
        <a:graphic>
          <a:graphicData uri="http://schemas.openxmlformats.org/drawingml/2006/table">
            <a:tbl>
              <a:tblPr/>
              <a:tblGrid>
                <a:gridCol w="575531"/>
                <a:gridCol w="2194214"/>
              </a:tblGrid>
              <a:tr h="19783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ungal species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 dirty="0" err="1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Aspergillus</a:t>
                      </a:r>
                      <a:r>
                        <a:rPr lang="en-AU" sz="1000" b="0" i="1" u="none" strike="noStrike" dirty="0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AU" sz="1000" b="0" i="1" u="none" strike="noStrike" dirty="0" err="1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terreus</a:t>
                      </a:r>
                      <a:endParaRPr lang="en-AU" sz="1000" b="0" i="1" u="none" strike="noStrike" dirty="0">
                        <a:solidFill>
                          <a:srgbClr val="222222"/>
                        </a:solidFill>
                        <a:effectLst/>
                        <a:latin typeface="Arial"/>
                      </a:endParaRP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Truchoderma longibrachiatum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3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Penicillium sp.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4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Hypocrea lixii 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5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Acremonium sp.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6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Aspergillus niger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7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Aspergillus tubingensis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8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Aspergillus fumigatus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9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Penicillium janthinellum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0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Trichoderma atroviride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1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0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2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Rhizomucor pusillus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3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0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4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cor circinelloides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5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0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3651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6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 dirty="0" err="1" smtClean="0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Antarctomyces</a:t>
                      </a:r>
                      <a:r>
                        <a:rPr lang="en-AU" sz="1000" b="0" i="1" u="none" strike="noStrike" dirty="0" smtClean="0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AU" sz="1000" b="0" i="1" u="none" strike="noStrike" dirty="0" err="1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psychrotrophicus</a:t>
                      </a:r>
                      <a:endParaRPr lang="en-AU" sz="1000" b="0" i="1" u="none" strike="noStrike" dirty="0">
                        <a:solidFill>
                          <a:srgbClr val="222222"/>
                        </a:solidFill>
                        <a:effectLst/>
                        <a:latin typeface="Arial"/>
                      </a:endParaRP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7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0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8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Corynascus verrucosus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19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Neosartorya fischeri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0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1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Sordariales sp.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25932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2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 dirty="0" err="1" smtClean="0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Thermomyces</a:t>
                      </a:r>
                      <a:r>
                        <a:rPr lang="en-AU" sz="1000" b="0" i="1" u="none" strike="noStrike" dirty="0" smtClean="0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AU" sz="1000" b="0" i="1" u="none" strike="noStrike" dirty="0" err="1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lanuginosus</a:t>
                      </a:r>
                      <a:endParaRPr lang="en-AU" sz="1000" b="0" i="1" u="none" strike="noStrike" dirty="0">
                        <a:solidFill>
                          <a:srgbClr val="222222"/>
                        </a:solidFill>
                        <a:effectLst/>
                        <a:latin typeface="Arial"/>
                      </a:endParaRP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3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Penicillium chrysogenum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4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5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0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6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Rhizomucor pusillus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7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8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Myceliophthora thermophila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29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30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0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None identified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31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0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ichoderma sp.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32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Aspergillus terreus</a:t>
                      </a: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67264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33</a:t>
                      </a:r>
                    </a:p>
                  </a:txBody>
                  <a:tcPr marL="8993" marR="8993" marT="899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1000" b="0" i="1" u="none" strike="noStrike" dirty="0" err="1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Chaetomium</a:t>
                      </a:r>
                      <a:r>
                        <a:rPr lang="en-AU" sz="1000" b="0" i="1" u="none" strike="noStrike" dirty="0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AU" sz="1000" b="0" i="1" u="none" strike="noStrike" dirty="0" err="1">
                          <a:solidFill>
                            <a:srgbClr val="222222"/>
                          </a:solidFill>
                          <a:effectLst/>
                          <a:latin typeface="Arial"/>
                        </a:rPr>
                        <a:t>globosum</a:t>
                      </a:r>
                      <a:endParaRPr lang="en-AU" sz="1000" b="0" i="1" u="none" strike="noStrike" dirty="0">
                        <a:solidFill>
                          <a:srgbClr val="222222"/>
                        </a:solidFill>
                        <a:effectLst/>
                        <a:latin typeface="Arial"/>
                      </a:endParaRPr>
                    </a:p>
                  </a:txBody>
                  <a:tcPr marL="8993" marR="8993" marT="899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825626" y="8460432"/>
            <a:ext cx="166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dditional file </a:t>
            </a:r>
            <a:r>
              <a:rPr lang="en-AU" dirty="0" smtClean="0"/>
              <a:t>2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4517430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21</TotalTime>
  <Words>151</Words>
  <Application>Microsoft Office PowerPoint</Application>
  <PresentationFormat>On-screen Show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MIT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yn Mouradov</dc:creator>
  <cp:lastModifiedBy>Aidyn Mouradov</cp:lastModifiedBy>
  <cp:revision>641</cp:revision>
  <cp:lastPrinted>2014-06-15T22:26:20Z</cp:lastPrinted>
  <dcterms:created xsi:type="dcterms:W3CDTF">2013-11-06T00:27:51Z</dcterms:created>
  <dcterms:modified xsi:type="dcterms:W3CDTF">2014-07-01T00:41:48Z</dcterms:modified>
</cp:coreProperties>
</file>